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7" r:id="rId2"/>
    <p:sldId id="261" r:id="rId3"/>
    <p:sldId id="264" r:id="rId4"/>
    <p:sldId id="265" r:id="rId5"/>
    <p:sldId id="260" r:id="rId6"/>
    <p:sldId id="262" r:id="rId7"/>
    <p:sldId id="266" r:id="rId8"/>
    <p:sldId id="267" r:id="rId9"/>
    <p:sldId id="269" r:id="rId10"/>
    <p:sldId id="270" r:id="rId11"/>
    <p:sldId id="259" r:id="rId12"/>
    <p:sldId id="263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23" autoAdjust="0"/>
    <p:restoredTop sz="81293"/>
  </p:normalViewPr>
  <p:slideViewPr>
    <p:cSldViewPr snapToGrid="0">
      <p:cViewPr varScale="1">
        <p:scale>
          <a:sx n="106" d="100"/>
          <a:sy n="106" d="100"/>
        </p:scale>
        <p:origin x="786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95D14D-74C3-4E9D-8BF5-3AC045662B62}" type="datetimeFigureOut">
              <a:rPr lang="en-IN" smtClean="0"/>
              <a:t>08-04-2021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29933B-E385-4A51-A9FF-6B4B1670663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66485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 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sv-SE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11EDE58-BAEF-40EF-8911-BA42E5A87956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1234953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b="1" dirty="0">
              <a:solidFill>
                <a:srgbClr val="FFFF00"/>
              </a:solidFill>
              <a:latin typeface="Arial Hebrew Scholar" charset="-79"/>
              <a:ea typeface="Arial Hebrew Scholar" charset="-79"/>
              <a:cs typeface="Arial Hebrew Scholar" charset="-79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11EDE58-BAEF-40EF-8911-BA42E5A87956}" type="slidenum">
              <a:rPr lang="sv-SE" smtClean="0"/>
              <a:t>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434533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11EDE58-BAEF-40EF-8911-BA42E5A87956}" type="slidenum">
              <a:rPr lang="sv-SE" smtClean="0"/>
              <a:t>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658474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F43F-B1A8-4CE9-9565-08C9B54C2594}" type="datetimeFigureOut">
              <a:rPr lang="en-IN" smtClean="0"/>
              <a:t>08-04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04B5-69FA-468D-915D-3E4A7381A2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21273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F43F-B1A8-4CE9-9565-08C9B54C2594}" type="datetimeFigureOut">
              <a:rPr lang="en-IN" smtClean="0"/>
              <a:t>08-04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04B5-69FA-468D-915D-3E4A7381A2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524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F43F-B1A8-4CE9-9565-08C9B54C2594}" type="datetimeFigureOut">
              <a:rPr lang="en-IN" smtClean="0"/>
              <a:t>08-04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04B5-69FA-468D-915D-3E4A7381A2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51024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F43F-B1A8-4CE9-9565-08C9B54C2594}" type="datetimeFigureOut">
              <a:rPr lang="en-IN" smtClean="0"/>
              <a:t>08-04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04B5-69FA-468D-915D-3E4A7381A2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90707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F43F-B1A8-4CE9-9565-08C9B54C2594}" type="datetimeFigureOut">
              <a:rPr lang="en-IN" smtClean="0"/>
              <a:t>08-04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04B5-69FA-468D-915D-3E4A7381A2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7481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F43F-B1A8-4CE9-9565-08C9B54C2594}" type="datetimeFigureOut">
              <a:rPr lang="en-IN" smtClean="0"/>
              <a:t>08-04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04B5-69FA-468D-915D-3E4A7381A2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75098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F43F-B1A8-4CE9-9565-08C9B54C2594}" type="datetimeFigureOut">
              <a:rPr lang="en-IN" smtClean="0"/>
              <a:t>08-04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04B5-69FA-468D-915D-3E4A7381A2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82265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F43F-B1A8-4CE9-9565-08C9B54C2594}" type="datetimeFigureOut">
              <a:rPr lang="en-IN" smtClean="0"/>
              <a:t>08-04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04B5-69FA-468D-915D-3E4A7381A2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3974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F43F-B1A8-4CE9-9565-08C9B54C2594}" type="datetimeFigureOut">
              <a:rPr lang="en-IN" smtClean="0"/>
              <a:t>08-04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04B5-69FA-468D-915D-3E4A7381A2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05442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F43F-B1A8-4CE9-9565-08C9B54C2594}" type="datetimeFigureOut">
              <a:rPr lang="en-IN" smtClean="0"/>
              <a:t>08-04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04B5-69FA-468D-915D-3E4A7381A2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82607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F43F-B1A8-4CE9-9565-08C9B54C2594}" type="datetimeFigureOut">
              <a:rPr lang="en-IN" smtClean="0"/>
              <a:t>08-04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04B5-69FA-468D-915D-3E4A7381A2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81032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DF43F-B1A8-4CE9-9565-08C9B54C2594}" type="datetimeFigureOut">
              <a:rPr lang="en-IN" smtClean="0"/>
              <a:t>08-04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204B5-69FA-468D-915D-3E4A7381A2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38531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image" Target="../media/image16.tiff"/><Relationship Id="rId7" Type="http://schemas.openxmlformats.org/officeDocument/2006/relationships/oleObject" Target="../embeddings/oleObject5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tiff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2351" y="791655"/>
            <a:ext cx="2307998" cy="302146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8450" y="831755"/>
            <a:ext cx="2306881" cy="302615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13475" y="1237833"/>
            <a:ext cx="2758068" cy="222382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6263" y="6385467"/>
            <a:ext cx="19314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.1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479384" y="500132"/>
            <a:ext cx="7244327" cy="5614469"/>
            <a:chOff x="1479384" y="500132"/>
            <a:chExt cx="7244327" cy="5614469"/>
          </a:xfrm>
        </p:grpSpPr>
        <p:sp>
          <p:nvSpPr>
            <p:cNvPr id="9" name="TextBox 8"/>
            <p:cNvSpPr txBox="1"/>
            <p:nvPr/>
          </p:nvSpPr>
          <p:spPr>
            <a:xfrm>
              <a:off x="1479384" y="50013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a</a:t>
              </a:r>
            </a:p>
          </p:txBody>
        </p:sp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20417" y="4522939"/>
              <a:ext cx="1797306" cy="1415686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29128" y="4493073"/>
              <a:ext cx="1794583" cy="1387470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3818745" y="5852991"/>
              <a:ext cx="8640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Rhod2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844250" y="5807637"/>
              <a:ext cx="13681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mito-case12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555302" y="4079637"/>
              <a:ext cx="2712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d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723302" y="408054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119186" y="509514"/>
              <a:ext cx="2712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b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878401" y="509514"/>
              <a:ext cx="2712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8078525" y="3387256"/>
              <a:ext cx="645186" cy="2265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4843742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00963A2-ABD8-2245-B370-697151466C2F}"/>
              </a:ext>
            </a:extLst>
          </p:cNvPr>
          <p:cNvSpPr/>
          <p:nvPr/>
        </p:nvSpPr>
        <p:spPr>
          <a:xfrm>
            <a:off x="497058" y="491392"/>
            <a:ext cx="11197883" cy="50379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. Extended analysis of </a:t>
            </a:r>
            <a:r>
              <a:rPr lang="en-US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O mice phenotype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(A)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1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RNA expression in wild type (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2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-300 islets per mouse, 3 technical replicates per mouse) and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O islets (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2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-300 islets per mouse, 3 technical replicates per mouse). (B) Insulin secretion in figure 4E normalized to insulin content shown in figure 4G.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.b.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igure 4E and figure 4G were performed using separate islets, therefore, the wild type and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 KO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ulin secretion values were normalized to the mean of wildtype and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O islet content, respectively. (C) Representative western blot analysis of mitochondrial complexes I-V (CI-V) in wild type and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O islets, each lane is from a single mouse,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3 for wild type and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O. (D) Quantification of mitochondrial complexes I-V (CI-V) in wild type and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O islets.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s were made with an unpaired two-tailed Student’s t-test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** P&lt;0.0001</a:t>
            </a:r>
            <a:endParaRPr lang="en-GB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068803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3009" y="2156612"/>
            <a:ext cx="2428146" cy="2490204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27611" y="2366467"/>
            <a:ext cx="2369055" cy="1908159"/>
          </a:xfrm>
          <a:prstGeom prst="rect">
            <a:avLst/>
          </a:prstGeom>
        </p:spPr>
      </p:pic>
      <p:grpSp>
        <p:nvGrpSpPr>
          <p:cNvPr id="6" name="Group 5"/>
          <p:cNvGrpSpPr/>
          <p:nvPr/>
        </p:nvGrpSpPr>
        <p:grpSpPr>
          <a:xfrm>
            <a:off x="1236237" y="1883572"/>
            <a:ext cx="7587078" cy="5374047"/>
            <a:chOff x="2063552" y="350861"/>
            <a:chExt cx="7587078" cy="5374047"/>
          </a:xfrm>
        </p:grpSpPr>
        <p:grpSp>
          <p:nvGrpSpPr>
            <p:cNvPr id="4" name="Group 3"/>
            <p:cNvGrpSpPr/>
            <p:nvPr/>
          </p:nvGrpSpPr>
          <p:grpSpPr>
            <a:xfrm>
              <a:off x="2063552" y="350861"/>
              <a:ext cx="7587078" cy="1709987"/>
              <a:chOff x="2063552" y="350861"/>
              <a:chExt cx="7587078" cy="1709987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2063552" y="362291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a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4200771" y="350861"/>
                <a:ext cx="27122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b</a:t>
                </a:r>
              </a:p>
            </p:txBody>
          </p:sp>
          <p:grpSp>
            <p:nvGrpSpPr>
              <p:cNvPr id="60" name="Group 59"/>
              <p:cNvGrpSpPr/>
              <p:nvPr/>
            </p:nvGrpSpPr>
            <p:grpSpPr>
              <a:xfrm>
                <a:off x="4316916" y="1310368"/>
                <a:ext cx="2283140" cy="750480"/>
                <a:chOff x="2474976" y="2542032"/>
                <a:chExt cx="2283140" cy="750480"/>
              </a:xfrm>
            </p:grpSpPr>
            <p:pic>
              <p:nvPicPr>
                <p:cNvPr id="61" name="Picture 60"/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090" t="45845" r="54596" b="51273"/>
                <a:stretch>
                  <a:fillRect/>
                </a:stretch>
              </p:blipFill>
              <p:spPr>
                <a:xfrm>
                  <a:off x="3630168" y="2606040"/>
                  <a:ext cx="896112" cy="155448"/>
                </a:xfrm>
                <a:prstGeom prst="rect">
                  <a:avLst/>
                </a:prstGeom>
              </p:spPr>
            </p:pic>
            <p:grpSp>
              <p:nvGrpSpPr>
                <p:cNvPr id="62" name="Group 61"/>
                <p:cNvGrpSpPr/>
                <p:nvPr/>
              </p:nvGrpSpPr>
              <p:grpSpPr>
                <a:xfrm>
                  <a:off x="2474976" y="2542032"/>
                  <a:ext cx="2283140" cy="750480"/>
                  <a:chOff x="2474976" y="2542032"/>
                  <a:chExt cx="2283140" cy="750480"/>
                </a:xfrm>
              </p:grpSpPr>
              <p:pic>
                <p:nvPicPr>
                  <p:cNvPr id="63" name="Picture 62"/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6072" t="39975" r="54928" b="56821"/>
                  <a:stretch>
                    <a:fillRect/>
                  </a:stretch>
                </p:blipFill>
                <p:spPr>
                  <a:xfrm>
                    <a:off x="3611880" y="2743200"/>
                    <a:ext cx="905256" cy="201168"/>
                  </a:xfrm>
                  <a:prstGeom prst="rect">
                    <a:avLst/>
                  </a:prstGeom>
                </p:spPr>
              </p:pic>
              <p:sp>
                <p:nvSpPr>
                  <p:cNvPr id="64" name="Right Arrow 63"/>
                  <p:cNvSpPr/>
                  <p:nvPr/>
                </p:nvSpPr>
                <p:spPr>
                  <a:xfrm>
                    <a:off x="3447288" y="2615184"/>
                    <a:ext cx="173736" cy="128016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sv-SE"/>
                  </a:p>
                </p:txBody>
              </p:sp>
              <p:sp>
                <p:nvSpPr>
                  <p:cNvPr id="65" name="TextBox 64"/>
                  <p:cNvSpPr txBox="1"/>
                  <p:nvPr/>
                </p:nvSpPr>
                <p:spPr>
                  <a:xfrm>
                    <a:off x="2779776" y="2542032"/>
                    <a:ext cx="66751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sv-SE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ICU2</a:t>
                    </a:r>
                  </a:p>
                </p:txBody>
              </p:sp>
              <p:sp>
                <p:nvSpPr>
                  <p:cNvPr id="66" name="Right Arrow 65"/>
                  <p:cNvSpPr/>
                  <p:nvPr/>
                </p:nvSpPr>
                <p:spPr>
                  <a:xfrm>
                    <a:off x="3435096" y="2795016"/>
                    <a:ext cx="173736" cy="128016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sv-SE"/>
                  </a:p>
                </p:txBody>
              </p:sp>
              <p:sp>
                <p:nvSpPr>
                  <p:cNvPr id="67" name="TextBox 66"/>
                  <p:cNvSpPr txBox="1"/>
                  <p:nvPr/>
                </p:nvSpPr>
                <p:spPr>
                  <a:xfrm>
                    <a:off x="2474976" y="2731008"/>
                    <a:ext cx="1008888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sv-SE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TUBULIN</a:t>
                    </a:r>
                  </a:p>
                </p:txBody>
              </p:sp>
              <p:sp>
                <p:nvSpPr>
                  <p:cNvPr id="68" name="TextBox 67"/>
                  <p:cNvSpPr txBox="1"/>
                  <p:nvPr/>
                </p:nvSpPr>
                <p:spPr>
                  <a:xfrm>
                    <a:off x="3481362" y="3015513"/>
                    <a:ext cx="60174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sv-SE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 NC</a:t>
                    </a:r>
                  </a:p>
                </p:txBody>
              </p:sp>
              <p:sp>
                <p:nvSpPr>
                  <p:cNvPr id="69" name="TextBox 68"/>
                  <p:cNvSpPr txBox="1"/>
                  <p:nvPr/>
                </p:nvSpPr>
                <p:spPr>
                  <a:xfrm>
                    <a:off x="3931698" y="3015513"/>
                    <a:ext cx="826418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sv-SE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 </a:t>
                    </a:r>
                    <a:r>
                      <a:rPr lang="sv-SE" sz="12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icu2</a:t>
                    </a:r>
                  </a:p>
                </p:txBody>
              </p:sp>
              <p:sp>
                <p:nvSpPr>
                  <p:cNvPr id="70" name="Right Arrow 69"/>
                  <p:cNvSpPr/>
                  <p:nvPr/>
                </p:nvSpPr>
                <p:spPr>
                  <a:xfrm rot="16200000">
                    <a:off x="3735324" y="2939796"/>
                    <a:ext cx="146304" cy="118872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sv-SE"/>
                  </a:p>
                </p:txBody>
              </p:sp>
              <p:sp>
                <p:nvSpPr>
                  <p:cNvPr id="71" name="Right Arrow 70"/>
                  <p:cNvSpPr/>
                  <p:nvPr/>
                </p:nvSpPr>
                <p:spPr>
                  <a:xfrm rot="16200000">
                    <a:off x="4079748" y="2945892"/>
                    <a:ext cx="146304" cy="118872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sv-SE"/>
                  </a:p>
                </p:txBody>
              </p:sp>
            </p:grpSp>
          </p:grpSp>
          <p:sp>
            <p:nvSpPr>
              <p:cNvPr id="36" name="TextBox 35"/>
              <p:cNvSpPr txBox="1"/>
              <p:nvPr/>
            </p:nvSpPr>
            <p:spPr>
              <a:xfrm>
                <a:off x="6714564" y="352020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c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9379402" y="362291"/>
                <a:ext cx="27122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d</a:t>
                </a:r>
              </a:p>
            </p:txBody>
          </p:sp>
          <p:cxnSp>
            <p:nvCxnSpPr>
              <p:cNvPr id="3" name="Straight Connector 2"/>
              <p:cNvCxnSpPr/>
              <p:nvPr/>
            </p:nvCxnSpPr>
            <p:spPr>
              <a:xfrm flipH="1">
                <a:off x="2280285" y="833756"/>
                <a:ext cx="40640" cy="317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" name="Rectangle 12"/>
            <p:cNvSpPr/>
            <p:nvPr/>
          </p:nvSpPr>
          <p:spPr>
            <a:xfrm>
              <a:off x="2798466" y="5565913"/>
              <a:ext cx="473544" cy="15899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4" name="Rectangle 13"/>
          <p:cNvSpPr/>
          <p:nvPr/>
        </p:nvSpPr>
        <p:spPr>
          <a:xfrm>
            <a:off x="1410652" y="2308350"/>
            <a:ext cx="124529" cy="873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E045FC9-D0A8-6B48-8CAA-9BAC6F00637A}"/>
              </a:ext>
            </a:extLst>
          </p:cNvPr>
          <p:cNvSpPr txBox="1">
            <a:spLocks noChangeAspect="1"/>
          </p:cNvSpPr>
          <p:nvPr/>
        </p:nvSpPr>
        <p:spPr>
          <a:xfrm>
            <a:off x="162927" y="6404805"/>
            <a:ext cx="1994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. 6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0CF75A1A-C72D-40C4-8C5B-3CB6092A85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2988574"/>
              </p:ext>
            </p:extLst>
          </p:nvPr>
        </p:nvGraphicFramePr>
        <p:xfrm>
          <a:off x="6079829" y="2128145"/>
          <a:ext cx="2828925" cy="2570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2829586" imgH="2570419" progId="Prism9.Document">
                  <p:embed/>
                </p:oleObj>
              </mc:Choice>
              <mc:Fallback>
                <p:oleObj name="Prism 9" r:id="rId7" imgW="2829586" imgH="25704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079829" y="2128145"/>
                        <a:ext cx="2828925" cy="2570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5764040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00963A2-ABD8-2245-B370-697151466C2F}"/>
              </a:ext>
            </a:extLst>
          </p:cNvPr>
          <p:cNvSpPr/>
          <p:nvPr/>
        </p:nvSpPr>
        <p:spPr>
          <a:xfrm>
            <a:off x="497058" y="491392"/>
            <a:ext cx="11197883" cy="37514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. Data demonstrating knock down efficiency of </a:t>
            </a:r>
            <a:r>
              <a:rPr lang="en-US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its functional quantification in HEK-293T cells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(A)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RNA expression in HEK-293T cells.  (B) Representative western blot analysis of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fter knock down in HEK-293T cells; (C) quantification of MICU2 protein by Western blot analysis. Analysis was performed 72 h after treatment with scrambled siRNA or si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Experiments were repeated at least three times. (D) Quantification of time to maximal peak [Ca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baseline="-25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to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levation based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n data derived from Figure 5A. Mean ± SEM are given. Comparisons were made with an unpaired two-tailed Student’s t-test. ** P&lt;0.01 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41986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1163625-10F9-C640-91E9-3B5EB73A5FA1}"/>
              </a:ext>
            </a:extLst>
          </p:cNvPr>
          <p:cNvSpPr/>
          <p:nvPr/>
        </p:nvSpPr>
        <p:spPr>
          <a:xfrm>
            <a:off x="633044" y="432311"/>
            <a:ext cx="10972801" cy="479156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 MCU and MICU1 expression upon MICU2 silencing, extended analysis of [Ca</a:t>
            </a:r>
            <a:r>
              <a:rPr lang="en-US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+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b="1" baseline="-25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to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pon MICU2 knock down and representative images showing mitochondria loaded or transfected with Rhod2 and </a:t>
            </a:r>
            <a:r>
              <a:rPr lang="en-US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to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ase 12 respectively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60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cu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RNA expression and (B)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1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RNA expression in INS1 832/13 cells treated with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C and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C) shows quantification of time to maximal peak for [Ca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baseline="-25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to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sed on data derived from Figure 1G. (D) Representative images showing loading of Rhod2 in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l-GR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1 (E) and transfection of mito-case12 in INS-1 832/13 cells. Mean ± SEM are given.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s were made with an unpaired two-tailed Student’s t-test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* P&lt;0.05. 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65381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1610942E-49E5-1645-8221-88721FAB7B83}"/>
              </a:ext>
            </a:extLst>
          </p:cNvPr>
          <p:cNvGrpSpPr/>
          <p:nvPr/>
        </p:nvGrpSpPr>
        <p:grpSpPr>
          <a:xfrm>
            <a:off x="162927" y="4159759"/>
            <a:ext cx="9665109" cy="2552823"/>
            <a:chOff x="683186" y="2255354"/>
            <a:chExt cx="9665109" cy="2552823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E045FC9-D0A8-6B48-8CAA-9BAC6F00637A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83186" y="4500400"/>
              <a:ext cx="19944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Supplementary Fig. 2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329E9253-F724-EC41-B7CB-008B1EB3FEA6}"/>
                </a:ext>
              </a:extLst>
            </p:cNvPr>
            <p:cNvSpPr/>
            <p:nvPr/>
          </p:nvSpPr>
          <p:spPr>
            <a:xfrm>
              <a:off x="1895168" y="3392129"/>
              <a:ext cx="589935" cy="2026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A9313026-5891-594C-AA01-585533F5EFDA}"/>
                </a:ext>
              </a:extLst>
            </p:cNvPr>
            <p:cNvSpPr/>
            <p:nvPr/>
          </p:nvSpPr>
          <p:spPr>
            <a:xfrm>
              <a:off x="9758360" y="2595992"/>
              <a:ext cx="589935" cy="2026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5FC656BC-A158-BA4C-AC77-5D3EB161AFEC}"/>
                </a:ext>
              </a:extLst>
            </p:cNvPr>
            <p:cNvSpPr/>
            <p:nvPr/>
          </p:nvSpPr>
          <p:spPr>
            <a:xfrm>
              <a:off x="6787877" y="2255354"/>
              <a:ext cx="133838" cy="39584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02DFE134-4A75-194C-9B32-F0E00F6FF3AB}"/>
                </a:ext>
              </a:extLst>
            </p:cNvPr>
            <p:cNvSpPr/>
            <p:nvPr/>
          </p:nvSpPr>
          <p:spPr>
            <a:xfrm>
              <a:off x="6502793" y="2364493"/>
              <a:ext cx="69257" cy="3922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Freeform 9">
              <a:extLst>
                <a:ext uri="{FF2B5EF4-FFF2-40B4-BE49-F238E27FC236}">
                  <a16:creationId xmlns:a16="http://schemas.microsoft.com/office/drawing/2014/main" id="{547D0FE1-FC76-C745-B9E1-86B718539EC4}"/>
                </a:ext>
              </a:extLst>
            </p:cNvPr>
            <p:cNvSpPr/>
            <p:nvPr/>
          </p:nvSpPr>
          <p:spPr>
            <a:xfrm>
              <a:off x="6501600" y="2302669"/>
              <a:ext cx="61200" cy="57150"/>
            </a:xfrm>
            <a:custGeom>
              <a:avLst/>
              <a:gdLst>
                <a:gd name="connsiteX0" fmla="*/ 0 w 54829"/>
                <a:gd name="connsiteY0" fmla="*/ 54769 h 57150"/>
                <a:gd name="connsiteX1" fmla="*/ 2381 w 54829"/>
                <a:gd name="connsiteY1" fmla="*/ 42862 h 57150"/>
                <a:gd name="connsiteX2" fmla="*/ 11906 w 54829"/>
                <a:gd name="connsiteY2" fmla="*/ 14287 h 57150"/>
                <a:gd name="connsiteX3" fmla="*/ 16669 w 54829"/>
                <a:gd name="connsiteY3" fmla="*/ 9525 h 57150"/>
                <a:gd name="connsiteX4" fmla="*/ 19050 w 54829"/>
                <a:gd name="connsiteY4" fmla="*/ 19050 h 57150"/>
                <a:gd name="connsiteX5" fmla="*/ 21431 w 54829"/>
                <a:gd name="connsiteY5" fmla="*/ 30956 h 57150"/>
                <a:gd name="connsiteX6" fmla="*/ 26194 w 54829"/>
                <a:gd name="connsiteY6" fmla="*/ 57150 h 57150"/>
                <a:gd name="connsiteX7" fmla="*/ 28575 w 54829"/>
                <a:gd name="connsiteY7" fmla="*/ 11906 h 57150"/>
                <a:gd name="connsiteX8" fmla="*/ 33337 w 54829"/>
                <a:gd name="connsiteY8" fmla="*/ 21431 h 57150"/>
                <a:gd name="connsiteX9" fmla="*/ 35719 w 54829"/>
                <a:gd name="connsiteY9" fmla="*/ 28575 h 57150"/>
                <a:gd name="connsiteX10" fmla="*/ 40481 w 54829"/>
                <a:gd name="connsiteY10" fmla="*/ 7144 h 57150"/>
                <a:gd name="connsiteX11" fmla="*/ 47625 w 54829"/>
                <a:gd name="connsiteY11" fmla="*/ 19050 h 57150"/>
                <a:gd name="connsiteX12" fmla="*/ 52387 w 54829"/>
                <a:gd name="connsiteY12" fmla="*/ 33337 h 57150"/>
                <a:gd name="connsiteX13" fmla="*/ 47625 w 54829"/>
                <a:gd name="connsiteY13" fmla="*/ 23812 h 57150"/>
                <a:gd name="connsiteX14" fmla="*/ 45244 w 54829"/>
                <a:gd name="connsiteY14" fmla="*/ 7144 h 57150"/>
                <a:gd name="connsiteX15" fmla="*/ 47625 w 54829"/>
                <a:gd name="connsiteY15" fmla="*/ 21431 h 57150"/>
                <a:gd name="connsiteX16" fmla="*/ 42862 w 54829"/>
                <a:gd name="connsiteY16" fmla="*/ 9525 h 57150"/>
                <a:gd name="connsiteX17" fmla="*/ 33337 w 54829"/>
                <a:gd name="connsiteY17" fmla="*/ 0 h 57150"/>
                <a:gd name="connsiteX18" fmla="*/ 19050 w 54829"/>
                <a:gd name="connsiteY18" fmla="*/ 2381 h 57150"/>
                <a:gd name="connsiteX19" fmla="*/ 11906 w 54829"/>
                <a:gd name="connsiteY19" fmla="*/ 4762 h 57150"/>
                <a:gd name="connsiteX20" fmla="*/ 21431 w 54829"/>
                <a:gd name="connsiteY20" fmla="*/ 9525 h 57150"/>
                <a:gd name="connsiteX21" fmla="*/ 30956 w 54829"/>
                <a:gd name="connsiteY21" fmla="*/ 7144 h 57150"/>
                <a:gd name="connsiteX22" fmla="*/ 19050 w 54829"/>
                <a:gd name="connsiteY22" fmla="*/ 4762 h 57150"/>
                <a:gd name="connsiteX23" fmla="*/ 38100 w 54829"/>
                <a:gd name="connsiteY23" fmla="*/ 7144 h 57150"/>
                <a:gd name="connsiteX24" fmla="*/ 26194 w 54829"/>
                <a:gd name="connsiteY24" fmla="*/ 19050 h 57150"/>
                <a:gd name="connsiteX25" fmla="*/ 21431 w 54829"/>
                <a:gd name="connsiteY25" fmla="*/ 4762 h 57150"/>
                <a:gd name="connsiteX26" fmla="*/ 14287 w 54829"/>
                <a:gd name="connsiteY26" fmla="*/ 7144 h 57150"/>
                <a:gd name="connsiteX27" fmla="*/ 11906 w 54829"/>
                <a:gd name="connsiteY27" fmla="*/ 14287 h 57150"/>
                <a:gd name="connsiteX28" fmla="*/ 0 w 54829"/>
                <a:gd name="connsiteY28" fmla="*/ 26194 h 57150"/>
                <a:gd name="connsiteX29" fmla="*/ 2381 w 54829"/>
                <a:gd name="connsiteY29" fmla="*/ 40481 h 57150"/>
                <a:gd name="connsiteX30" fmla="*/ 9525 w 54829"/>
                <a:gd name="connsiteY30" fmla="*/ 38100 h 57150"/>
                <a:gd name="connsiteX31" fmla="*/ 21431 w 54829"/>
                <a:gd name="connsiteY31" fmla="*/ 26194 h 57150"/>
                <a:gd name="connsiteX32" fmla="*/ 38100 w 54829"/>
                <a:gd name="connsiteY32" fmla="*/ 33337 h 57150"/>
                <a:gd name="connsiteX33" fmla="*/ 42862 w 54829"/>
                <a:gd name="connsiteY33" fmla="*/ 40481 h 57150"/>
                <a:gd name="connsiteX34" fmla="*/ 45244 w 54829"/>
                <a:gd name="connsiteY34" fmla="*/ 47625 h 57150"/>
                <a:gd name="connsiteX35" fmla="*/ 52387 w 54829"/>
                <a:gd name="connsiteY35" fmla="*/ 50006 h 57150"/>
                <a:gd name="connsiteX36" fmla="*/ 50006 w 54829"/>
                <a:gd name="connsiteY36" fmla="*/ 35719 h 57150"/>
                <a:gd name="connsiteX37" fmla="*/ 47625 w 54829"/>
                <a:gd name="connsiteY37" fmla="*/ 26194 h 571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</a:cxnLst>
              <a:rect l="l" t="t" r="r" b="b"/>
              <a:pathLst>
                <a:path w="54829" h="57150">
                  <a:moveTo>
                    <a:pt x="0" y="54769"/>
                  </a:moveTo>
                  <a:cubicBezTo>
                    <a:pt x="794" y="50800"/>
                    <a:pt x="1934" y="46885"/>
                    <a:pt x="2381" y="42862"/>
                  </a:cubicBezTo>
                  <a:cubicBezTo>
                    <a:pt x="6057" y="9771"/>
                    <a:pt x="-5324" y="8545"/>
                    <a:pt x="11906" y="14287"/>
                  </a:cubicBezTo>
                  <a:cubicBezTo>
                    <a:pt x="16603" y="70654"/>
                    <a:pt x="11985" y="32943"/>
                    <a:pt x="16669" y="9525"/>
                  </a:cubicBezTo>
                  <a:cubicBezTo>
                    <a:pt x="17311" y="6316"/>
                    <a:pt x="18340" y="15855"/>
                    <a:pt x="19050" y="19050"/>
                  </a:cubicBezTo>
                  <a:cubicBezTo>
                    <a:pt x="19928" y="23001"/>
                    <a:pt x="20553" y="27005"/>
                    <a:pt x="21431" y="30956"/>
                  </a:cubicBezTo>
                  <a:cubicBezTo>
                    <a:pt x="25922" y="51169"/>
                    <a:pt x="22064" y="28250"/>
                    <a:pt x="26194" y="57150"/>
                  </a:cubicBezTo>
                  <a:cubicBezTo>
                    <a:pt x="26988" y="42069"/>
                    <a:pt x="25614" y="26715"/>
                    <a:pt x="28575" y="11906"/>
                  </a:cubicBezTo>
                  <a:cubicBezTo>
                    <a:pt x="29271" y="8425"/>
                    <a:pt x="31939" y="18168"/>
                    <a:pt x="33337" y="21431"/>
                  </a:cubicBezTo>
                  <a:cubicBezTo>
                    <a:pt x="34326" y="23738"/>
                    <a:pt x="34925" y="26194"/>
                    <a:pt x="35719" y="28575"/>
                  </a:cubicBezTo>
                  <a:cubicBezTo>
                    <a:pt x="41536" y="69302"/>
                    <a:pt x="34038" y="24862"/>
                    <a:pt x="40481" y="7144"/>
                  </a:cubicBezTo>
                  <a:cubicBezTo>
                    <a:pt x="42063" y="2794"/>
                    <a:pt x="45710" y="14837"/>
                    <a:pt x="47625" y="19050"/>
                  </a:cubicBezTo>
                  <a:cubicBezTo>
                    <a:pt x="49702" y="23620"/>
                    <a:pt x="54632" y="37827"/>
                    <a:pt x="52387" y="33337"/>
                  </a:cubicBezTo>
                  <a:lnTo>
                    <a:pt x="47625" y="23812"/>
                  </a:lnTo>
                  <a:cubicBezTo>
                    <a:pt x="46831" y="18256"/>
                    <a:pt x="45244" y="12756"/>
                    <a:pt x="45244" y="7144"/>
                  </a:cubicBezTo>
                  <a:cubicBezTo>
                    <a:pt x="45244" y="2316"/>
                    <a:pt x="51040" y="18018"/>
                    <a:pt x="47625" y="21431"/>
                  </a:cubicBezTo>
                  <a:cubicBezTo>
                    <a:pt x="44602" y="24453"/>
                    <a:pt x="44363" y="13527"/>
                    <a:pt x="42862" y="9525"/>
                  </a:cubicBezTo>
                  <a:cubicBezTo>
                    <a:pt x="39233" y="-152"/>
                    <a:pt x="43317" y="3326"/>
                    <a:pt x="33337" y="0"/>
                  </a:cubicBezTo>
                  <a:cubicBezTo>
                    <a:pt x="28575" y="794"/>
                    <a:pt x="23763" y="1334"/>
                    <a:pt x="19050" y="2381"/>
                  </a:cubicBezTo>
                  <a:cubicBezTo>
                    <a:pt x="16600" y="2925"/>
                    <a:pt x="11112" y="2381"/>
                    <a:pt x="11906" y="4762"/>
                  </a:cubicBezTo>
                  <a:cubicBezTo>
                    <a:pt x="13028" y="8130"/>
                    <a:pt x="18256" y="7937"/>
                    <a:pt x="21431" y="9525"/>
                  </a:cubicBezTo>
                  <a:cubicBezTo>
                    <a:pt x="24606" y="8731"/>
                    <a:pt x="32419" y="10071"/>
                    <a:pt x="30956" y="7144"/>
                  </a:cubicBezTo>
                  <a:cubicBezTo>
                    <a:pt x="29146" y="3524"/>
                    <a:pt x="15003" y="4762"/>
                    <a:pt x="19050" y="4762"/>
                  </a:cubicBezTo>
                  <a:cubicBezTo>
                    <a:pt x="25449" y="4762"/>
                    <a:pt x="31750" y="6350"/>
                    <a:pt x="38100" y="7144"/>
                  </a:cubicBezTo>
                  <a:cubicBezTo>
                    <a:pt x="37824" y="7558"/>
                    <a:pt x="29643" y="21809"/>
                    <a:pt x="26194" y="19050"/>
                  </a:cubicBezTo>
                  <a:cubicBezTo>
                    <a:pt x="22274" y="15914"/>
                    <a:pt x="21431" y="4762"/>
                    <a:pt x="21431" y="4762"/>
                  </a:cubicBezTo>
                  <a:cubicBezTo>
                    <a:pt x="19050" y="5556"/>
                    <a:pt x="16062" y="5369"/>
                    <a:pt x="14287" y="7144"/>
                  </a:cubicBezTo>
                  <a:cubicBezTo>
                    <a:pt x="12512" y="8919"/>
                    <a:pt x="13028" y="12042"/>
                    <a:pt x="11906" y="14287"/>
                  </a:cubicBezTo>
                  <a:cubicBezTo>
                    <a:pt x="7937" y="22225"/>
                    <a:pt x="7144" y="21431"/>
                    <a:pt x="0" y="26194"/>
                  </a:cubicBezTo>
                  <a:cubicBezTo>
                    <a:pt x="794" y="30956"/>
                    <a:pt x="-635" y="36711"/>
                    <a:pt x="2381" y="40481"/>
                  </a:cubicBezTo>
                  <a:cubicBezTo>
                    <a:pt x="3949" y="42441"/>
                    <a:pt x="7750" y="39875"/>
                    <a:pt x="9525" y="38100"/>
                  </a:cubicBezTo>
                  <a:cubicBezTo>
                    <a:pt x="24237" y="23388"/>
                    <a:pt x="4677" y="31778"/>
                    <a:pt x="21431" y="26194"/>
                  </a:cubicBezTo>
                  <a:cubicBezTo>
                    <a:pt x="28716" y="28015"/>
                    <a:pt x="32619" y="27856"/>
                    <a:pt x="38100" y="33337"/>
                  </a:cubicBezTo>
                  <a:cubicBezTo>
                    <a:pt x="40124" y="35361"/>
                    <a:pt x="41582" y="37921"/>
                    <a:pt x="42862" y="40481"/>
                  </a:cubicBezTo>
                  <a:cubicBezTo>
                    <a:pt x="43985" y="42726"/>
                    <a:pt x="43469" y="45850"/>
                    <a:pt x="45244" y="47625"/>
                  </a:cubicBezTo>
                  <a:cubicBezTo>
                    <a:pt x="47019" y="49400"/>
                    <a:pt x="50006" y="49212"/>
                    <a:pt x="52387" y="50006"/>
                  </a:cubicBezTo>
                  <a:cubicBezTo>
                    <a:pt x="56518" y="37616"/>
                    <a:pt x="55199" y="47836"/>
                    <a:pt x="50006" y="35719"/>
                  </a:cubicBezTo>
                  <a:cubicBezTo>
                    <a:pt x="48717" y="32711"/>
                    <a:pt x="47625" y="26194"/>
                    <a:pt x="47625" y="26194"/>
                  </a:cubicBezTo>
                </a:path>
              </a:pathLst>
            </a:cu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2985188"/>
              </p:ext>
            </p:extLst>
          </p:nvPr>
        </p:nvGraphicFramePr>
        <p:xfrm>
          <a:off x="1784350" y="36513"/>
          <a:ext cx="8624888" cy="6783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8624530" imgH="6783141" progId="Prism7.Document">
                  <p:embed/>
                </p:oleObj>
              </mc:Choice>
              <mc:Fallback>
                <p:oleObj name="Prism 7" r:id="rId2" imgW="8624530" imgH="6783141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784350" y="36513"/>
                        <a:ext cx="8624888" cy="6783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603082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A9DC5310-BC8E-E946-9B74-72923BAB7D44}"/>
              </a:ext>
            </a:extLst>
          </p:cNvPr>
          <p:cNvSpPr/>
          <p:nvPr/>
        </p:nvSpPr>
        <p:spPr>
          <a:xfrm>
            <a:off x="633044" y="432311"/>
            <a:ext cx="10972801" cy="470846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 </a:t>
            </a:r>
            <a:r>
              <a:rPr lang="sv-SE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normalized</a:t>
            </a:r>
            <a:r>
              <a:rPr lang="sv-SE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ata for [Ca</a:t>
            </a:r>
            <a:r>
              <a:rPr lang="sv-SE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+</a:t>
            </a:r>
            <a:r>
              <a:rPr lang="sv-SE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sv-SE" b="1" baseline="-25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to</a:t>
            </a:r>
            <a:r>
              <a:rPr lang="sv-SE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Ψ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and cytosolic ATP/ADP</a:t>
            </a:r>
            <a:r>
              <a:rPr lang="en-GB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io</a:t>
            </a:r>
            <a:endParaRPr lang="en-GB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60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Unnormalized [Ca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baseline="-25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to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vels, measured with mito-case12 fluorescence, in INS1 832/13 cells treated with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N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si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B) Unnormalized [Ca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baseline="-25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to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vels, measured with Rhod2 fluorescence, in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l-GR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1 cells treated with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N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si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C) Unnormalized 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Ψ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vels, measured with TMRM fluorescence, in INS1 832/13 cells treated with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N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si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D) Unnormalized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solic ATP/ADP</a:t>
            </a:r>
            <a:r>
              <a:rPr lang="en-GB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io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easured with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ceval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HR fluorescence, in INS1 832/13 cells treated with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N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si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Mean ± SEM are given.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s were made with an unpaired two-tailed Student’s t-test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*P&lt;0.05; ** P&lt;0.01; **** P&lt;0.0001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31043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2419670"/>
              </p:ext>
            </p:extLst>
          </p:nvPr>
        </p:nvGraphicFramePr>
        <p:xfrm>
          <a:off x="648898" y="2176427"/>
          <a:ext cx="3694788" cy="26835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3" imgW="5394113" imgH="3918476" progId="Prism7.Document">
                  <p:embed/>
                </p:oleObj>
              </mc:Choice>
              <mc:Fallback>
                <p:oleObj name="Prism 7" r:id="rId3" imgW="5394113" imgH="391847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48898" y="2176427"/>
                        <a:ext cx="3694788" cy="26835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4" name="Picture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4855" y="2426377"/>
            <a:ext cx="3814654" cy="243361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51510" y="2562012"/>
            <a:ext cx="2467233" cy="191239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829B192C-D639-5440-83CD-AF166EE6C5CF}"/>
              </a:ext>
            </a:extLst>
          </p:cNvPr>
          <p:cNvSpPr txBox="1"/>
          <p:nvPr/>
        </p:nvSpPr>
        <p:spPr>
          <a:xfrm>
            <a:off x="350418" y="1991761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F273114-6031-F24E-A276-E0B71FD6C030}"/>
              </a:ext>
            </a:extLst>
          </p:cNvPr>
          <p:cNvSpPr txBox="1"/>
          <p:nvPr/>
        </p:nvSpPr>
        <p:spPr>
          <a:xfrm>
            <a:off x="4694104" y="202322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6DB0B5D-0C94-4245-AC03-F31CCA22C466}"/>
              </a:ext>
            </a:extLst>
          </p:cNvPr>
          <p:cNvSpPr txBox="1"/>
          <p:nvPr/>
        </p:nvSpPr>
        <p:spPr>
          <a:xfrm>
            <a:off x="8803197" y="2023221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E045FC9-D0A8-6B48-8CAA-9BAC6F00637A}"/>
              </a:ext>
            </a:extLst>
          </p:cNvPr>
          <p:cNvSpPr txBox="1">
            <a:spLocks noChangeAspect="1"/>
          </p:cNvSpPr>
          <p:nvPr/>
        </p:nvSpPr>
        <p:spPr>
          <a:xfrm>
            <a:off x="162927" y="6404805"/>
            <a:ext cx="1994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. 3</a:t>
            </a:r>
          </a:p>
        </p:txBody>
      </p:sp>
    </p:spTree>
    <p:extLst>
      <p:ext uri="{BB962C8B-B14F-4D97-AF65-F5344CB8AC3E}">
        <p14:creationId xmlns:p14="http://schemas.microsoft.com/office/powerpoint/2010/main" val="14234740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196891B-088F-7946-82D7-DC9413C8507A}"/>
              </a:ext>
            </a:extLst>
          </p:cNvPr>
          <p:cNvSpPr/>
          <p:nvPr/>
        </p:nvSpPr>
        <p:spPr>
          <a:xfrm>
            <a:off x="548639" y="671771"/>
            <a:ext cx="10719582" cy="41101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Extended analysis of [Ca</a:t>
            </a:r>
            <a:r>
              <a:rPr lang="en-US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+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b="1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pon </a:t>
            </a:r>
            <a:r>
              <a:rPr lang="en-US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nock down in INS-1 832/13 and </a:t>
            </a:r>
            <a:r>
              <a:rPr lang="en-US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C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l-GR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1 cells respectively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60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Mean average trace of [Ca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easured with Fluo4,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response to 16.7 mM glucose followed by 36 mM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Cl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INS-1 832/13 cells treated with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N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si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</a:t>
            </a:r>
            <a:r>
              <a:rPr lang="en-US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 shows [Ca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easurements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pon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nock down in response to stimulation with 50 mM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Cl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l-GR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1 cells. (C) shows quantification of maximal [Ca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levation upon 50 mM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Cl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imulation in (B).  Mean ± SEM are given.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s were made with an unpaired two-tailed Student’s t-test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** P&lt;0.01; **** P&lt;0.0001.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GB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11767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85D8EC4-E84F-F44B-97FE-9CEAE36F6049}"/>
              </a:ext>
            </a:extLst>
          </p:cNvPr>
          <p:cNvSpPr txBox="1">
            <a:spLocks noChangeAspect="1"/>
          </p:cNvSpPr>
          <p:nvPr/>
        </p:nvSpPr>
        <p:spPr>
          <a:xfrm>
            <a:off x="162927" y="6404805"/>
            <a:ext cx="1994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. 4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149" y="1799009"/>
            <a:ext cx="4838700" cy="3581400"/>
          </a:xfrm>
          <a:prstGeom prst="rect">
            <a:avLst/>
          </a:prstGeom>
        </p:spPr>
      </p:pic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5939902"/>
              </p:ext>
            </p:extLst>
          </p:nvPr>
        </p:nvGraphicFramePr>
        <p:xfrm>
          <a:off x="5118849" y="1665193"/>
          <a:ext cx="7130855" cy="38490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3" imgW="8202091" imgH="4427734" progId="Prism7.Document">
                  <p:embed/>
                </p:oleObj>
              </mc:Choice>
              <mc:Fallback>
                <p:oleObj name="Prism 7" r:id="rId3" imgW="8202091" imgH="442773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118849" y="1665193"/>
                        <a:ext cx="7130855" cy="38490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29B192C-D639-5440-83CD-AF166EE6C5CF}"/>
              </a:ext>
            </a:extLst>
          </p:cNvPr>
          <p:cNvSpPr txBox="1"/>
          <p:nvPr/>
        </p:nvSpPr>
        <p:spPr>
          <a:xfrm>
            <a:off x="272715" y="1631492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F273114-6031-F24E-A276-E0B71FD6C030}"/>
              </a:ext>
            </a:extLst>
          </p:cNvPr>
          <p:cNvSpPr txBox="1"/>
          <p:nvPr/>
        </p:nvSpPr>
        <p:spPr>
          <a:xfrm>
            <a:off x="5126283" y="166519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4813588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00963A2-ABD8-2245-B370-697151466C2F}"/>
              </a:ext>
            </a:extLst>
          </p:cNvPr>
          <p:cNvSpPr/>
          <p:nvPr/>
        </p:nvSpPr>
        <p:spPr>
          <a:xfrm>
            <a:off x="497058" y="491392"/>
            <a:ext cx="11197883" cy="31586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 Representation of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C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sv-S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1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scan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</a:t>
            </a:r>
            <a:endParaRPr lang="en-GB" sz="16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cna1a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cna1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RNA expression in INS1 832/13 cells treated with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N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si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u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B)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Ca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nsity across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C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H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~500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initiation of response to 36 mM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C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ells were of different sizes, therefore data were interpolated to standardize each cell to a set number of points, allowing for comparison. The X-axis represents cell axis, moving from one side of the plasma membrane (-50) through the center of the cell (0) to the opposite side of the plasma membrane (50). Points close to the extremities represent the submembrane region.</a:t>
            </a:r>
            <a:endParaRPr lang="en-GB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191274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19AACC47-E0A5-4845-A047-D53C5AF29776}"/>
              </a:ext>
            </a:extLst>
          </p:cNvPr>
          <p:cNvGrpSpPr>
            <a:grpSpLocks noChangeAspect="1"/>
          </p:cNvGrpSpPr>
          <p:nvPr/>
        </p:nvGrpSpPr>
        <p:grpSpPr>
          <a:xfrm>
            <a:off x="722484" y="3884243"/>
            <a:ext cx="5689437" cy="2339900"/>
            <a:chOff x="2751221" y="2791326"/>
            <a:chExt cx="6689558" cy="2751221"/>
          </a:xfrm>
        </p:grpSpPr>
        <p:grpSp>
          <p:nvGrpSpPr>
            <p:cNvPr id="2" name="Group 1"/>
            <p:cNvGrpSpPr/>
            <p:nvPr/>
          </p:nvGrpSpPr>
          <p:grpSpPr>
            <a:xfrm>
              <a:off x="2751221" y="2791326"/>
              <a:ext cx="6689558" cy="2751221"/>
              <a:chOff x="3272589" y="2237874"/>
              <a:chExt cx="6689558" cy="2751221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2"/>
              <a:srcRect l="32863" t="30242" r="26535" b="24122"/>
              <a:stretch/>
            </p:blipFill>
            <p:spPr>
              <a:xfrm>
                <a:off x="3272589" y="2237874"/>
                <a:ext cx="6689558" cy="2751221"/>
              </a:xfrm>
              <a:prstGeom prst="rect">
                <a:avLst/>
              </a:prstGeom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4427793" y="2374050"/>
                <a:ext cx="11112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b="1" dirty="0"/>
                  <a:t>Wild type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9111916" y="2983832"/>
                <a:ext cx="4395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b="1" dirty="0"/>
                  <a:t>CV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9111916" y="3244333"/>
                <a:ext cx="4892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b="1" dirty="0"/>
                  <a:t>CIII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9111916" y="3613665"/>
                <a:ext cx="50366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b="1" dirty="0"/>
                  <a:t>CIV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9111916" y="3818928"/>
                <a:ext cx="42832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b="1" dirty="0"/>
                  <a:t>CII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9140770" y="4111344"/>
                <a:ext cx="36580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b="1" dirty="0"/>
                  <a:t>CI</a:t>
                </a:r>
              </a:p>
            </p:txBody>
          </p:sp>
        </p:grpSp>
        <p:sp>
          <p:nvSpPr>
            <p:cNvPr id="3" name="Right Brace 2"/>
            <p:cNvSpPr/>
            <p:nvPr/>
          </p:nvSpPr>
          <p:spPr>
            <a:xfrm rot="16200000">
              <a:off x="4357753" y="2288471"/>
              <a:ext cx="208547" cy="2497624"/>
            </a:xfrm>
            <a:prstGeom prst="rightBrac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Right Brace 15"/>
            <p:cNvSpPr/>
            <p:nvPr/>
          </p:nvSpPr>
          <p:spPr>
            <a:xfrm rot="16200000">
              <a:off x="7141942" y="2185292"/>
              <a:ext cx="208547" cy="2688668"/>
            </a:xfrm>
            <a:prstGeom prst="rightBrac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698123" y="2923673"/>
              <a:ext cx="1303456" cy="4055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b="1" i="1" dirty="0"/>
                <a:t>Micu2 </a:t>
              </a:r>
              <a:r>
                <a:rPr lang="sv-SE" b="1" dirty="0"/>
                <a:t>KO</a:t>
              </a:r>
              <a:endParaRPr lang="en-GB" b="1" i="1" dirty="0"/>
            </a:p>
          </p:txBody>
        </p:sp>
      </p:grpSp>
      <p:pic>
        <p:nvPicPr>
          <p:cNvPr id="18" name="Picture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71508" y="3739555"/>
            <a:ext cx="3839209" cy="2492007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829B192C-D639-5440-83CD-AF166EE6C5CF}"/>
              </a:ext>
            </a:extLst>
          </p:cNvPr>
          <p:cNvSpPr txBox="1"/>
          <p:nvPr/>
        </p:nvSpPr>
        <p:spPr>
          <a:xfrm>
            <a:off x="722484" y="316723"/>
            <a:ext cx="298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F273114-6031-F24E-A276-E0B71FD6C030}"/>
              </a:ext>
            </a:extLst>
          </p:cNvPr>
          <p:cNvSpPr txBox="1"/>
          <p:nvPr/>
        </p:nvSpPr>
        <p:spPr>
          <a:xfrm>
            <a:off x="6257872" y="34373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52808" y="6453337"/>
            <a:ext cx="1994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. 5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60CD62CE-25A4-4C3F-BEC9-C41013B7AB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189129"/>
              </p:ext>
            </p:extLst>
          </p:nvPr>
        </p:nvGraphicFramePr>
        <p:xfrm>
          <a:off x="1350036" y="430142"/>
          <a:ext cx="2867025" cy="3027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866320" imgH="3027815" progId="Prism9.Document">
                  <p:embed/>
                </p:oleObj>
              </mc:Choice>
              <mc:Fallback>
                <p:oleObj name="Prism 9" r:id="rId4" imgW="2866320" imgH="302781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350036" y="430142"/>
                        <a:ext cx="2867025" cy="3027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24BDE686-6D0A-4FF2-B6D3-C89654193505}"/>
              </a:ext>
            </a:extLst>
          </p:cNvPr>
          <p:cNvSpPr txBox="1"/>
          <p:nvPr/>
        </p:nvSpPr>
        <p:spPr>
          <a:xfrm>
            <a:off x="8600239" y="2095297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2271344-4801-4BE1-96E1-43B49EF7743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41651" y="343735"/>
            <a:ext cx="4739292" cy="3255424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049C408D-BCDC-4A50-A53A-6690531F83AC}"/>
              </a:ext>
            </a:extLst>
          </p:cNvPr>
          <p:cNvSpPr txBox="1"/>
          <p:nvPr/>
        </p:nvSpPr>
        <p:spPr>
          <a:xfrm>
            <a:off x="797063" y="3370223"/>
            <a:ext cx="298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21642B8-D084-4C53-9B15-169B1A70D2AF}"/>
              </a:ext>
            </a:extLst>
          </p:cNvPr>
          <p:cNvSpPr txBox="1"/>
          <p:nvPr/>
        </p:nvSpPr>
        <p:spPr>
          <a:xfrm>
            <a:off x="6716520" y="3472489"/>
            <a:ext cx="298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966805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4</TotalTime>
  <Words>928</Words>
  <Application>Microsoft Office PowerPoint</Application>
  <PresentationFormat>Widescreen</PresentationFormat>
  <Paragraphs>68</Paragraphs>
  <Slides>12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2</vt:i4>
      </vt:variant>
    </vt:vector>
  </HeadingPairs>
  <TitlesOfParts>
    <vt:vector size="21" baseType="lpstr">
      <vt:lpstr>Arial</vt:lpstr>
      <vt:lpstr>Arial Hebrew Scholar</vt:lpstr>
      <vt:lpstr>Calibri</vt:lpstr>
      <vt:lpstr>Calibri Light</vt:lpstr>
      <vt:lpstr>Helvetica</vt:lpstr>
      <vt:lpstr>Times New Roman</vt:lpstr>
      <vt:lpstr>Office Theme</vt:lpstr>
      <vt:lpstr>Prism 7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elanjan</dc:creator>
  <cp:lastModifiedBy>Alexander Hamilton</cp:lastModifiedBy>
  <cp:revision>75</cp:revision>
  <dcterms:created xsi:type="dcterms:W3CDTF">2017-07-28T11:23:06Z</dcterms:created>
  <dcterms:modified xsi:type="dcterms:W3CDTF">2021-04-08T08:46:10Z</dcterms:modified>
</cp:coreProperties>
</file>